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  <p:sldId id="270" r:id="rId3"/>
    <p:sldId id="272" r:id="rId4"/>
    <p:sldId id="285" r:id="rId5"/>
    <p:sldId id="286" r:id="rId6"/>
    <p:sldId id="275" r:id="rId7"/>
    <p:sldId id="28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78" d="100"/>
          <a:sy n="78" d="100"/>
        </p:scale>
        <p:origin x="78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AECB31-A798-CF4D-92C9-D481C6F764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8049D1-65F8-61CD-D6C4-35212D37A2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AA9F71-A033-09A2-4EBA-468BF0A4D1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F7FCAB-81CC-5ACC-123A-D6B4A0417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335D32-F0C5-F2EE-674E-FF80BF1ADF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944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8C1F0A-AACC-F5BD-A79D-1E2BF72ACE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1EF1EB-4493-A62F-B20E-8DAF0FE162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CA87BE-35CE-B13C-AB51-1A062E2822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627BF5-3B26-670A-E3EF-6A69865A9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9757E9-9893-E612-EAA4-A938FD1A3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724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0660BF-F5E0-6745-2D84-8E50AF05E0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A6943E-A4EA-8076-51D8-90B6BF0CF7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C712AA-2149-4D13-6C42-8A2FAA6E01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131B83-C1AC-0B3F-67EF-C39A7BE639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EE69D4-B6AD-C533-79BF-2363E4BC8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0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548F29-0EAC-C055-3351-A62EDB0BA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F93E4D-E623-9A19-8AE3-7567BEE8B6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A61DC5-8EB8-6C32-4EEA-5E2281A55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36B1C6-E314-4D14-4F24-859870AD2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FB2DBE-0D2B-88EB-FBE3-801059A38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821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2C103E-EDC9-679A-D371-805019666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D95E4E-AA71-3ADB-49CB-42E257D670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F5392D-A33E-6742-152F-5B076F49A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5170DD-5525-4E89-4D1F-9A3EDAA53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7DDA96-229F-3954-E00E-37B4CCB6C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40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6A908E-0944-E577-F166-00B99424F9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121EC9-29FD-CF97-D6DF-D4D9A0D5E8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EFD57B-522F-769C-DF44-FBC628213A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BA9BB7-A331-38B5-E127-608E0CA9D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74D58B-8534-8CAB-99D2-20BEB9967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D65A50-2FB2-F799-57E1-8E4E07412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472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5C6767-FE50-6454-BF5F-ACB3D5EBBF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E07872-B0EE-6EFD-B914-9587BBFBB5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B25082-2423-61F4-F802-89848B69D5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7B22C8-6CC3-9368-E083-9CFAE88875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6059A5-8742-F910-3232-AC8B0308A2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96BF9C-7D52-28A2-5125-E46C8FB36A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5F77A3D-A5A6-357F-1C12-B81263B49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6D8F99-C7E6-D863-1B38-5B6EE47C4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591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3762CD-7009-F0F9-4641-DE048987CA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FDBA0CF-7A5D-99CB-0D06-F29199CB61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2AA551-F88B-5288-BFB6-3C4244CF7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7B4DBC-CF3C-C63B-4DA2-39573ACC0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238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539C03-157C-AC60-2CE5-6EC0EE0E6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C0953D0-BD64-1FD3-A5B7-997AD94F5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54A14B-CF6E-A12A-2BC4-FA768AFA54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19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5BE194-103A-0EF2-5FEC-BD29260A90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E7A405-FA57-9A0F-F9FD-4B764101CE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18425E-9E09-809C-B53D-5AF3234082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7D3601-B6B8-7F7A-95CA-776B7F68F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C25102-F7C2-2055-4ED2-467D5FF3F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C03B8C-60A0-3468-C3F1-2269771EC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643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3BEDD-2260-7F91-FBDD-A87AA5518D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C06584B-EA8B-468E-8873-FF1FCF542B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9F3890-F0B2-1678-5632-263983577D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6FDF88-5E18-FE1D-1E44-E8C944523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4F4657-3BF1-D4D4-D755-F6712E3AB6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153105-566A-F74B-AB64-119FFBB3B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319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86428D7-A9F5-B0FE-415D-E1C0DF36D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F256C9-7F48-366D-404F-6E415CAF45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A8832B-36A1-AEBF-5BDE-922F3B9F23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C7FB7D-09BE-4AE1-B4B4-759A6ADD64EC}" type="datetimeFigureOut">
              <a:rPr lang="en-US" smtClean="0"/>
              <a:t>10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F41D50-CCFE-5446-7965-63478B3BCF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EA63B0-94B0-B619-444D-FF885602D2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89F47EF-B808-42ED-8269-B5C1E88C1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448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C98DBC8-264C-EF61-D3B1-D167B43EB733}"/>
              </a:ext>
            </a:extLst>
          </p:cNvPr>
          <p:cNvSpPr txBox="1"/>
          <p:nvPr/>
        </p:nvSpPr>
        <p:spPr>
          <a:xfrm>
            <a:off x="3846580" y="5037189"/>
            <a:ext cx="47489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u="sng" dirty="0"/>
              <a:t>Supplementary Figures and Dat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1391FE7-A9F8-4BA8-5E45-069AAEAF02CC}"/>
              </a:ext>
            </a:extLst>
          </p:cNvPr>
          <p:cNvSpPr txBox="1"/>
          <p:nvPr/>
        </p:nvSpPr>
        <p:spPr>
          <a:xfrm>
            <a:off x="717754" y="835742"/>
            <a:ext cx="10107561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ost Wire-Bonding Corrosion Prevention Strategies to  Mitigate Chloride- and Bromide-Induced Corrosion Failures in Cu- and PCC-Based Wire-Bonded Packages</a:t>
            </a:r>
          </a:p>
          <a:p>
            <a:endParaRPr lang="en-US" b="1" dirty="0"/>
          </a:p>
          <a:p>
            <a:r>
              <a:rPr lang="en-US" b="1" dirty="0"/>
              <a:t>Dinesh Kumar Kumaravel </a:t>
            </a:r>
            <a:r>
              <a:rPr lang="en-US" b="1" baseline="30000" dirty="0"/>
              <a:t>1</a:t>
            </a:r>
            <a:r>
              <a:rPr lang="en-US" b="1" dirty="0"/>
              <a:t>, Shinoj Sridharan Nair </a:t>
            </a:r>
            <a:r>
              <a:rPr lang="en-US" b="1" baseline="30000" dirty="0"/>
              <a:t>1</a:t>
            </a:r>
            <a:r>
              <a:rPr lang="en-US" b="1" dirty="0"/>
              <a:t>, Khanh Tuyet Anh Tran </a:t>
            </a:r>
            <a:r>
              <a:rPr lang="en-US" b="1" baseline="30000" dirty="0"/>
              <a:t>1</a:t>
            </a:r>
            <a:r>
              <a:rPr lang="en-US" b="1" dirty="0"/>
              <a:t>, Pavan Ahluwalia </a:t>
            </a:r>
            <a:r>
              <a:rPr lang="en-US" b="1" baseline="30000" dirty="0"/>
              <a:t>2</a:t>
            </a:r>
            <a:r>
              <a:rPr lang="en-US" b="1" dirty="0"/>
              <a:t>, </a:t>
            </a:r>
            <a:br>
              <a:rPr lang="en-US" b="1" dirty="0"/>
            </a:br>
            <a:r>
              <a:rPr lang="en-US" b="1" dirty="0"/>
              <a:t>Kevin Antony Jesu Durai </a:t>
            </a:r>
            <a:r>
              <a:rPr lang="en-US" b="1" baseline="30000" dirty="0"/>
              <a:t>1</a:t>
            </a:r>
            <a:r>
              <a:rPr lang="en-US" b="1" dirty="0"/>
              <a:t> and Oliver Chyan </a:t>
            </a:r>
            <a:r>
              <a:rPr lang="en-US" b="1" baseline="30000" dirty="0"/>
              <a:t>1,</a:t>
            </a:r>
            <a:r>
              <a:rPr lang="en-US" b="1" dirty="0"/>
              <a:t>*</a:t>
            </a:r>
          </a:p>
          <a:p>
            <a:endParaRPr lang="en-US" b="1" dirty="0"/>
          </a:p>
          <a:p>
            <a:r>
              <a:rPr lang="en-US" baseline="30000" dirty="0"/>
              <a:t>1</a:t>
            </a:r>
            <a:r>
              <a:rPr lang="en-US" dirty="0"/>
              <a:t>  Department of Chemistry, University of North Texas, Denton, TX 76201, USA;</a:t>
            </a:r>
            <a:br>
              <a:rPr lang="en-US" dirty="0"/>
            </a:br>
            <a:r>
              <a:rPr lang="en-US" dirty="0"/>
              <a:t>khanhtran5@my.unt.edu (K.T.A.T.); kevinantony@my.unt.edu (K.A.J.D.)</a:t>
            </a:r>
          </a:p>
          <a:p>
            <a:r>
              <a:rPr lang="en-US" baseline="30000" dirty="0"/>
              <a:t>2</a:t>
            </a:r>
            <a:r>
              <a:rPr lang="en-US" dirty="0"/>
              <a:t>  Texas Academy of Mathematics and Science, University of North Texas, Denton, TX 76201, USA</a:t>
            </a:r>
            <a:br>
              <a:rPr lang="en-US" dirty="0"/>
            </a:br>
            <a:r>
              <a:rPr lang="en-US" b="1" dirty="0"/>
              <a:t>*  </a:t>
            </a:r>
            <a:r>
              <a:rPr lang="en-US" dirty="0"/>
              <a:t>Correspondence: oliverm.chyan@unt.edu; Tel.: +1-(940)-565-3463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60193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C58B3E9-F649-1361-7CD7-C1D8B077ECA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82" t="30692" r="23789" b="26415"/>
          <a:stretch/>
        </p:blipFill>
        <p:spPr>
          <a:xfrm>
            <a:off x="350833" y="404126"/>
            <a:ext cx="4077377" cy="1931091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92D3016E-4D52-4C9C-56C6-3B0E5350631D}"/>
              </a:ext>
            </a:extLst>
          </p:cNvPr>
          <p:cNvGrpSpPr/>
          <p:nvPr/>
        </p:nvGrpSpPr>
        <p:grpSpPr>
          <a:xfrm>
            <a:off x="462275" y="2969577"/>
            <a:ext cx="3733722" cy="2379937"/>
            <a:chOff x="5722487" y="1651930"/>
            <a:chExt cx="3733722" cy="2379937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6811D2E-03E2-3F74-3AA6-A34A85E7B9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323"/>
            <a:stretch/>
          </p:blipFill>
          <p:spPr>
            <a:xfrm>
              <a:off x="5722487" y="1651930"/>
              <a:ext cx="3733722" cy="237993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92EB5D9-8C9D-9E77-8F52-6C6A4D0E195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82873" y="1784961"/>
              <a:ext cx="1866861" cy="140014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48A0594-5F12-BDD3-15FC-A020D1E7A52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55249" y="1783704"/>
              <a:ext cx="1722107" cy="1389743"/>
            </a:xfrm>
            <a:prstGeom prst="rect">
              <a:avLst/>
            </a:prstGeom>
          </p:spPr>
        </p:pic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51017087-3DA9-2098-2515-C2A00EBFAD7B}"/>
                </a:ext>
              </a:extLst>
            </p:cNvPr>
            <p:cNvGrpSpPr/>
            <p:nvPr/>
          </p:nvGrpSpPr>
          <p:grpSpPr>
            <a:xfrm>
              <a:off x="7619973" y="1766526"/>
              <a:ext cx="1794776" cy="1429153"/>
              <a:chOff x="7930728" y="4437862"/>
              <a:chExt cx="2267519" cy="1790330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E9262520-59B1-D529-85AE-5D1F10BEB4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35625" y="4437862"/>
                <a:ext cx="2262622" cy="1777086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A4CCD76E-D5F4-A2C5-FA3E-6CEE028B838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30728" y="4451106"/>
                <a:ext cx="2262620" cy="1777086"/>
              </a:xfrm>
              <a:prstGeom prst="rect">
                <a:avLst/>
              </a:prstGeom>
            </p:spPr>
          </p:pic>
        </p:grp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E9C5191D-D9F1-3393-0240-2A8649567545}"/>
              </a:ext>
            </a:extLst>
          </p:cNvPr>
          <p:cNvSpPr txBox="1"/>
          <p:nvPr/>
        </p:nvSpPr>
        <p:spPr>
          <a:xfrm>
            <a:off x="802531" y="2434279"/>
            <a:ext cx="2675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ptical Microscope (500x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6C40E06-4BB6-BCD1-8879-5E9E8A151ADF}"/>
              </a:ext>
            </a:extLst>
          </p:cNvPr>
          <p:cNvSpPr txBox="1"/>
          <p:nvPr/>
        </p:nvSpPr>
        <p:spPr>
          <a:xfrm>
            <a:off x="2005447" y="5921359"/>
            <a:ext cx="9192725" cy="6155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5715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M-EDX Analysis of the Control non-passivated PCC</a:t>
            </a:r>
            <a:r>
              <a:rPr lang="en-US" dirty="0"/>
              <a:t>−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 devices showing copper rich and palladium rich region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E0918C1-9719-FBFF-6190-B8E672214486}"/>
              </a:ext>
            </a:extLst>
          </p:cNvPr>
          <p:cNvSpPr txBox="1"/>
          <p:nvPr/>
        </p:nvSpPr>
        <p:spPr>
          <a:xfrm>
            <a:off x="677358" y="3468466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a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5FDBE28-B57E-846E-7B28-274FF6F24FE1}"/>
              </a:ext>
            </a:extLst>
          </p:cNvPr>
          <p:cNvSpPr txBox="1"/>
          <p:nvPr/>
        </p:nvSpPr>
        <p:spPr>
          <a:xfrm>
            <a:off x="1456090" y="3335778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b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02CD14A-8C0B-66FD-E404-964B0B3A27C2}"/>
              </a:ext>
            </a:extLst>
          </p:cNvPr>
          <p:cNvSpPr txBox="1"/>
          <p:nvPr/>
        </p:nvSpPr>
        <p:spPr>
          <a:xfrm>
            <a:off x="2492674" y="3424131"/>
            <a:ext cx="375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c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3843EFD-D122-442C-F51A-BE3F39D26B60}"/>
              </a:ext>
            </a:extLst>
          </p:cNvPr>
          <p:cNvSpPr txBox="1"/>
          <p:nvPr/>
        </p:nvSpPr>
        <p:spPr>
          <a:xfrm>
            <a:off x="3690671" y="3283800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d.</a:t>
            </a:r>
          </a:p>
        </p:txBody>
      </p:sp>
      <p:graphicFrame>
        <p:nvGraphicFramePr>
          <p:cNvPr id="28" name="Table 27">
            <a:extLst>
              <a:ext uri="{FF2B5EF4-FFF2-40B4-BE49-F238E27FC236}">
                <a16:creationId xmlns:a16="http://schemas.microsoft.com/office/drawing/2014/main" id="{B326ACB7-6F1E-D421-918E-3B8B11D29F1C}"/>
              </a:ext>
            </a:extLst>
          </p:cNvPr>
          <p:cNvGraphicFramePr>
            <a:graphicFrameLocks noGrp="1"/>
          </p:cNvGraphicFramePr>
          <p:nvPr/>
        </p:nvGraphicFramePr>
        <p:xfrm>
          <a:off x="5766087" y="2067805"/>
          <a:ext cx="4578381" cy="2378421"/>
        </p:xfrm>
        <a:graphic>
          <a:graphicData uri="http://schemas.openxmlformats.org/drawingml/2006/table">
            <a:tbl>
              <a:tblPr firstRow="1" firstCol="1" bandRow="1"/>
              <a:tblGrid>
                <a:gridCol w="1526127">
                  <a:extLst>
                    <a:ext uri="{9D8B030D-6E8A-4147-A177-3AD203B41FA5}">
                      <a16:colId xmlns:a16="http://schemas.microsoft.com/office/drawing/2014/main" val="1364267593"/>
                    </a:ext>
                  </a:extLst>
                </a:gridCol>
                <a:gridCol w="1526127">
                  <a:extLst>
                    <a:ext uri="{9D8B030D-6E8A-4147-A177-3AD203B41FA5}">
                      <a16:colId xmlns:a16="http://schemas.microsoft.com/office/drawing/2014/main" val="2065694889"/>
                    </a:ext>
                  </a:extLst>
                </a:gridCol>
                <a:gridCol w="1526127">
                  <a:extLst>
                    <a:ext uri="{9D8B030D-6E8A-4147-A177-3AD203B41FA5}">
                      <a16:colId xmlns:a16="http://schemas.microsoft.com/office/drawing/2014/main" val="1677302174"/>
                    </a:ext>
                  </a:extLst>
                </a:gridCol>
              </a:tblGrid>
              <a:tr h="264269"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1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Spot 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1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Element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1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Atom%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6620276"/>
                  </a:ext>
                </a:extLst>
              </a:tr>
              <a:tr h="264269">
                <a:tc rowSpan="2"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a.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Cu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97.0 ± 0.5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9280613"/>
                  </a:ext>
                </a:extLst>
              </a:tr>
              <a:tr h="264269">
                <a:tc vMerge="1"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endParaRPr lang="en-US" sz="1000" b="0" i="0" u="none" dirty="0">
                        <a:solidFill>
                          <a:srgbClr val="000000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Pd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3.0 ± 0.4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8371775"/>
                  </a:ext>
                </a:extLst>
              </a:tr>
              <a:tr h="264269">
                <a:tc rowSpan="2"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b.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Cu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78.0 ± 0.5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9288508"/>
                  </a:ext>
                </a:extLst>
              </a:tr>
              <a:tr h="264269">
                <a:tc vMerge="1"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endParaRPr lang="en-US" sz="1000" b="0" i="0" u="none" dirty="0">
                        <a:solidFill>
                          <a:srgbClr val="000000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Pd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22.0 ± 0.7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6526902"/>
                  </a:ext>
                </a:extLst>
              </a:tr>
              <a:tr h="264269">
                <a:tc rowSpan="2"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c.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Cu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96.0 ± 0.5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6577733"/>
                  </a:ext>
                </a:extLst>
              </a:tr>
              <a:tr h="264269">
                <a:tc vMerge="1"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endParaRPr lang="en-US" sz="1000" b="0" i="0" u="none" dirty="0">
                        <a:solidFill>
                          <a:srgbClr val="000000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Pd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4.0 ± 0.4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3485419"/>
                  </a:ext>
                </a:extLst>
              </a:tr>
              <a:tr h="264269">
                <a:tc rowSpan="2"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1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d.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Cu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auto" latinLnBrk="0" hangingPunct="1">
                        <a:lnSpc>
                          <a:spcPts val="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</a:rPr>
                        <a:t>78.5% </a:t>
                      </a: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± 0.5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6907728"/>
                  </a:ext>
                </a:extLst>
              </a:tr>
              <a:tr h="26426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Pd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1.5% ± 0.4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2294652"/>
                  </a:ext>
                </a:extLst>
              </a:tr>
            </a:tbl>
          </a:graphicData>
        </a:graphic>
      </p:graphicFrame>
      <p:sp>
        <p:nvSpPr>
          <p:cNvPr id="29" name="Rectangle 3">
            <a:extLst>
              <a:ext uri="{FF2B5EF4-FFF2-40B4-BE49-F238E27FC236}">
                <a16:creationId xmlns:a16="http://schemas.microsoft.com/office/drawing/2014/main" id="{3EB5FE2B-41DA-E1E6-14FA-9FABF3BEEF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535661"/>
            <a:ext cx="380104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Table A1. </a:t>
            </a:r>
            <a:r>
              <a:rPr lang="en-US" alt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EDX results of the polygon scan on top of ball bonds</a:t>
            </a:r>
            <a:endParaRPr kumimoji="0" lang="en-US" altLang="en-US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64227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1EBA407-9383-4670-7873-3BCEF26D73B2}"/>
              </a:ext>
            </a:extLst>
          </p:cNvPr>
          <p:cNvSpPr txBox="1"/>
          <p:nvPr/>
        </p:nvSpPr>
        <p:spPr>
          <a:xfrm>
            <a:off x="1694534" y="4619080"/>
            <a:ext cx="9192725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5715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2.</a:t>
            </a: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M-EDX Analysis of Cu</a:t>
            </a:r>
            <a:r>
              <a:rPr lang="en-US" dirty="0"/>
              <a:t>−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 devices after 24 h of </a:t>
            </a:r>
            <a:r>
              <a:rPr lang="en-US" sz="1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ersion in 0.5% in NTMP contaminated 100 ppm Cl</a:t>
            </a:r>
            <a:r>
              <a:rPr lang="en-US" sz="16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lution indicated no structural change to the Al bond pad, and EDX-analysis detected a non-quantifiable presence of a phosphorous signal.</a:t>
            </a:r>
            <a:endParaRPr lang="en-US" sz="16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99722442-B545-DBCE-68A6-96B690F35C5C}"/>
              </a:ext>
            </a:extLst>
          </p:cNvPr>
          <p:cNvGraphicFramePr>
            <a:graphicFrameLocks noGrp="1"/>
          </p:cNvGraphicFramePr>
          <p:nvPr/>
        </p:nvGraphicFramePr>
        <p:xfrm>
          <a:off x="6113982" y="1681512"/>
          <a:ext cx="4578380" cy="2114152"/>
        </p:xfrm>
        <a:graphic>
          <a:graphicData uri="http://schemas.openxmlformats.org/drawingml/2006/table">
            <a:tbl>
              <a:tblPr firstRow="1" firstCol="1" bandRow="1"/>
              <a:tblGrid>
                <a:gridCol w="2289190">
                  <a:extLst>
                    <a:ext uri="{9D8B030D-6E8A-4147-A177-3AD203B41FA5}">
                      <a16:colId xmlns:a16="http://schemas.microsoft.com/office/drawing/2014/main" val="2065694889"/>
                    </a:ext>
                  </a:extLst>
                </a:gridCol>
                <a:gridCol w="2289190">
                  <a:extLst>
                    <a:ext uri="{9D8B030D-6E8A-4147-A177-3AD203B41FA5}">
                      <a16:colId xmlns:a16="http://schemas.microsoft.com/office/drawing/2014/main" val="1677302174"/>
                    </a:ext>
                  </a:extLst>
                </a:gridCol>
              </a:tblGrid>
              <a:tr h="264269"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1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Element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1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Atom%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6620276"/>
                  </a:ext>
                </a:extLst>
              </a:tr>
              <a:tr h="264269"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C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2.66 ± 0.22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9280613"/>
                  </a:ext>
                </a:extLst>
              </a:tr>
              <a:tr h="264269"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N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0.27 ± 0.14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8371775"/>
                  </a:ext>
                </a:extLst>
              </a:tr>
              <a:tr h="264269"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O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1.99 ± 0.25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9288508"/>
                  </a:ext>
                </a:extLst>
              </a:tr>
              <a:tr h="264269"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Al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94.36 ± 2.10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6526902"/>
                  </a:ext>
                </a:extLst>
              </a:tr>
              <a:tr h="264269"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P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0.54 ± 0.32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6577733"/>
                  </a:ext>
                </a:extLst>
              </a:tr>
              <a:tr h="264269"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Cu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0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0.18 ± 0.10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3485419"/>
                  </a:ext>
                </a:extLst>
              </a:tr>
              <a:tr h="264269"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1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Total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eaLnBrk="0">
                        <a:lnSpc>
                          <a:spcPts val="600"/>
                        </a:lnSpc>
                      </a:pPr>
                      <a:r>
                        <a:rPr lang="en-US" sz="1000" b="1" i="0" u="none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</a:rPr>
                        <a:t>100.00</a:t>
                      </a:r>
                    </a:p>
                  </a:txBody>
                  <a:tcPr marL="8464" marR="8464" marT="8464" marB="846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6907728"/>
                  </a:ext>
                </a:extLst>
              </a:tr>
            </a:tbl>
          </a:graphicData>
        </a:graphic>
      </p:graphicFrame>
      <p:sp>
        <p:nvSpPr>
          <p:cNvPr id="12" name="Rectangle 3">
            <a:extLst>
              <a:ext uri="{FF2B5EF4-FFF2-40B4-BE49-F238E27FC236}">
                <a16:creationId xmlns:a16="http://schemas.microsoft.com/office/drawing/2014/main" id="{D4AD256C-FC56-5D4C-B879-562F94DAD9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55260" y="1169026"/>
            <a:ext cx="3124573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Table A2. </a:t>
            </a:r>
            <a:r>
              <a:rPr lang="en-US" alt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EDX results of the Circular polygon scan</a:t>
            </a:r>
            <a:endParaRPr kumimoji="0" lang="en-US" altLang="en-US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7FBAF750-E139-0AFF-BC6A-DB9DB244B5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4534" y="1407923"/>
            <a:ext cx="3103133" cy="24995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42287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55146D9-8916-456B-D7B7-9AECA504847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AD6B637-351A-B8D4-D56D-5EDF8F62A649}"/>
              </a:ext>
            </a:extLst>
          </p:cNvPr>
          <p:cNvSpPr txBox="1"/>
          <p:nvPr/>
        </p:nvSpPr>
        <p:spPr>
          <a:xfrm>
            <a:off x="1063319" y="6205785"/>
            <a:ext cx="10446728" cy="6155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5715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M-EDX Map Analysis of Cu</a:t>
            </a:r>
            <a:r>
              <a:rPr lang="en-US" dirty="0"/>
              <a:t>−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 devices after 24 h of </a:t>
            </a:r>
            <a:r>
              <a:rPr lang="en-US" sz="1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ersion in 0.5% NTMP contaminated 100 ppm Cl</a:t>
            </a:r>
            <a:r>
              <a:rPr lang="en-US" sz="16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lution indicated a non-quantifiable presence of a phosphorus signal.</a:t>
            </a:r>
            <a:endParaRPr lang="en-US" sz="16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08AE322-AE2A-17AD-52E2-17F6705574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615" y="359827"/>
            <a:ext cx="11357832" cy="57429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96248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46B47C1-B208-2ABD-8F1C-813172DBA0B3}"/>
              </a:ext>
            </a:extLst>
          </p:cNvPr>
          <p:cNvSpPr txBox="1"/>
          <p:nvPr/>
        </p:nvSpPr>
        <p:spPr>
          <a:xfrm>
            <a:off x="1608747" y="6182195"/>
            <a:ext cx="9782060" cy="6155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5715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M-EDX Map Analysis on PCC</a:t>
            </a:r>
            <a:r>
              <a:rPr lang="en-US" dirty="0"/>
              <a:t>−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 devices after 24 h of </a:t>
            </a:r>
            <a:r>
              <a:rPr lang="en-US" sz="1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ersion in 0.5% NTMP contaminated 100 ppm Cl</a:t>
            </a:r>
            <a:r>
              <a:rPr lang="en-US" sz="16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lution indicated a non-quantifiable presence of a phosphorus signal.</a:t>
            </a:r>
            <a:endParaRPr lang="en-US" sz="16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152A8C8-16F8-A208-B525-79EA3DD791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616" y="383417"/>
            <a:ext cx="11559018" cy="57673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01482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AAB5645-E014-7CC2-CBC3-0D01B3CEB6D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FC08D1F-2F2D-C38D-47B4-E6584DDF392E}"/>
              </a:ext>
            </a:extLst>
          </p:cNvPr>
          <p:cNvSpPr txBox="1"/>
          <p:nvPr/>
        </p:nvSpPr>
        <p:spPr>
          <a:xfrm>
            <a:off x="1128545" y="5389537"/>
            <a:ext cx="945784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5.</a:t>
            </a: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tentiodynamic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olarization plots confirming the reduction </a:t>
            </a:r>
            <a:r>
              <a:rPr lang="en-US" sz="1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l wafer reactivity in the presence of NTMP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2FE44DE-B824-8003-33A3-F3089A4DF04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493" t="9362" r="12067" b="4539"/>
          <a:stretch/>
        </p:blipFill>
        <p:spPr>
          <a:xfrm>
            <a:off x="3686782" y="772956"/>
            <a:ext cx="5300535" cy="42898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39894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4073D21A-1B64-2947-CE02-26CDBEB8442E}"/>
              </a:ext>
            </a:extLst>
          </p:cNvPr>
          <p:cNvSpPr txBox="1"/>
          <p:nvPr/>
        </p:nvSpPr>
        <p:spPr>
          <a:xfrm>
            <a:off x="619558" y="5061982"/>
            <a:ext cx="945784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6.</a:t>
            </a: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P spectra of P-2p </a:t>
            </a:r>
            <a:r>
              <a:rPr lang="en-US" sz="16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u wafers in NTMP solutions indicate an absence of P-O-Cu peak at 133 eV after water rinsing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F0806F6-2661-0C04-D8EC-2539A2D50D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1075" y="927195"/>
            <a:ext cx="4950381" cy="36701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7736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37f4b8a2-ad4f-41b5-9a91-284d2cc38f56}" enabled="1" method="Standard" siteId="{70de1992-07c6-480f-a318-a1afcba03983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439</Words>
  <Application>Microsoft Office PowerPoint</Application>
  <PresentationFormat>Widescreen</PresentationFormat>
  <Paragraphs>5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North Texa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maravel, Dinesh Kumar</dc:creator>
  <cp:lastModifiedBy>MDPI</cp:lastModifiedBy>
  <cp:revision>4</cp:revision>
  <dcterms:created xsi:type="dcterms:W3CDTF">2025-10-06T23:59:37Z</dcterms:created>
  <dcterms:modified xsi:type="dcterms:W3CDTF">2025-10-12T02:42:04Z</dcterms:modified>
</cp:coreProperties>
</file>